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1" r:id="rId2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35"/>
    <p:restoredTop sz="94807"/>
  </p:normalViewPr>
  <p:slideViewPr>
    <p:cSldViewPr snapToGrid="0" snapToObjects="1">
      <p:cViewPr varScale="1">
        <p:scale>
          <a:sx n="93" d="100"/>
          <a:sy n="93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F39BB6-8E07-EC49-98F9-E398AF662058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C5D5B-D510-C349-8F3F-67AA3A654E2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81484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481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3550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63542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26102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8397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5637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7630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76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4446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5416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357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49477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EDD57F80-41D1-6A4C-977E-185FAA18CE76}"/>
              </a:ext>
            </a:extLst>
          </p:cNvPr>
          <p:cNvGrpSpPr/>
          <p:nvPr/>
        </p:nvGrpSpPr>
        <p:grpSpPr>
          <a:xfrm>
            <a:off x="721360" y="792480"/>
            <a:ext cx="5626735" cy="4633595"/>
            <a:chOff x="0" y="211668"/>
            <a:chExt cx="5920840" cy="4805915"/>
          </a:xfrm>
        </p:grpSpPr>
        <p:grpSp>
          <p:nvGrpSpPr>
            <p:cNvPr id="6" name="Grupo 5">
              <a:extLst>
                <a:ext uri="{FF2B5EF4-FFF2-40B4-BE49-F238E27FC236}">
                  <a16:creationId xmlns:a16="http://schemas.microsoft.com/office/drawing/2014/main" id="{2EC874EF-8FD6-894B-A240-84667FD58265}"/>
                </a:ext>
              </a:extLst>
            </p:cNvPr>
            <p:cNvGrpSpPr/>
            <p:nvPr/>
          </p:nvGrpSpPr>
          <p:grpSpPr>
            <a:xfrm>
              <a:off x="0" y="211668"/>
              <a:ext cx="5920840" cy="4805915"/>
              <a:chOff x="0" y="211668"/>
              <a:chExt cx="5920840" cy="4805915"/>
            </a:xfrm>
          </p:grpSpPr>
          <p:grpSp>
            <p:nvGrpSpPr>
              <p:cNvPr id="9" name="Grupo 8">
                <a:extLst>
                  <a:ext uri="{FF2B5EF4-FFF2-40B4-BE49-F238E27FC236}">
                    <a16:creationId xmlns:a16="http://schemas.microsoft.com/office/drawing/2014/main" id="{0C103756-3D96-C447-88A4-5C787A5541A7}"/>
                  </a:ext>
                </a:extLst>
              </p:cNvPr>
              <p:cNvGrpSpPr/>
              <p:nvPr/>
            </p:nvGrpSpPr>
            <p:grpSpPr>
              <a:xfrm>
                <a:off x="0" y="211668"/>
                <a:ext cx="5920840" cy="4805915"/>
                <a:chOff x="0" y="211668"/>
                <a:chExt cx="5920840" cy="4805915"/>
              </a:xfrm>
            </p:grpSpPr>
            <p:pic>
              <p:nvPicPr>
                <p:cNvPr id="13" name="Imagen 12">
                  <a:extLst>
                    <a:ext uri="{FF2B5EF4-FFF2-40B4-BE49-F238E27FC236}">
                      <a16:creationId xmlns:a16="http://schemas.microsoft.com/office/drawing/2014/main" id="{40119A4C-D33A-E64A-A456-4C7B0212D6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0" y="211668"/>
                  <a:ext cx="5920840" cy="4805915"/>
                </a:xfrm>
                <a:prstGeom prst="rect">
                  <a:avLst/>
                </a:prstGeom>
              </p:spPr>
            </p:pic>
            <p:sp>
              <p:nvSpPr>
                <p:cNvPr id="14" name="Elipse 13">
                  <a:extLst>
                    <a:ext uri="{FF2B5EF4-FFF2-40B4-BE49-F238E27FC236}">
                      <a16:creationId xmlns:a16="http://schemas.microsoft.com/office/drawing/2014/main" id="{C754B064-7A8B-5844-A6BD-3ED06A23B579}"/>
                    </a:ext>
                  </a:extLst>
                </p:cNvPr>
                <p:cNvSpPr/>
                <p:nvPr/>
              </p:nvSpPr>
              <p:spPr>
                <a:xfrm rot="13813271">
                  <a:off x="771251" y="888424"/>
                  <a:ext cx="2761643" cy="1775462"/>
                </a:xfrm>
                <a:prstGeom prst="ellipse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s-ES_tradnl"/>
                </a:p>
              </p:txBody>
            </p:sp>
            <p:sp>
              <p:nvSpPr>
                <p:cNvPr id="15" name="Elipse 14">
                  <a:extLst>
                    <a:ext uri="{FF2B5EF4-FFF2-40B4-BE49-F238E27FC236}">
                      <a16:creationId xmlns:a16="http://schemas.microsoft.com/office/drawing/2014/main" id="{C35B7F2F-0A73-9A47-B810-11E7B1090E1C}"/>
                    </a:ext>
                  </a:extLst>
                </p:cNvPr>
                <p:cNvSpPr/>
                <p:nvPr/>
              </p:nvSpPr>
              <p:spPr>
                <a:xfrm>
                  <a:off x="1779318" y="2931108"/>
                  <a:ext cx="2339162" cy="1005613"/>
                </a:xfrm>
                <a:prstGeom prst="ellipse">
                  <a:avLst/>
                </a:prstGeom>
                <a:noFill/>
                <a:ln w="19050">
                  <a:solidFill>
                    <a:srgbClr val="383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s-ES_tradnl"/>
                </a:p>
              </p:txBody>
            </p:sp>
            <p:sp>
              <p:nvSpPr>
                <p:cNvPr id="16" name="Elipse 15">
                  <a:extLst>
                    <a:ext uri="{FF2B5EF4-FFF2-40B4-BE49-F238E27FC236}">
                      <a16:creationId xmlns:a16="http://schemas.microsoft.com/office/drawing/2014/main" id="{4DC4F362-AB40-B14F-9E96-B801639B380B}"/>
                    </a:ext>
                  </a:extLst>
                </p:cNvPr>
                <p:cNvSpPr/>
                <p:nvPr/>
              </p:nvSpPr>
              <p:spPr>
                <a:xfrm>
                  <a:off x="3824165" y="2144497"/>
                  <a:ext cx="1662338" cy="1429823"/>
                </a:xfrm>
                <a:prstGeom prst="ellipse">
                  <a:avLst/>
                </a:prstGeom>
                <a:noFill/>
                <a:ln w="19050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s-ES_tradnl"/>
                </a:p>
              </p:txBody>
            </p:sp>
            <p:sp>
              <p:nvSpPr>
                <p:cNvPr id="17" name="CuadroTexto 8">
                  <a:extLst>
                    <a:ext uri="{FF2B5EF4-FFF2-40B4-BE49-F238E27FC236}">
                      <a16:creationId xmlns:a16="http://schemas.microsoft.com/office/drawing/2014/main" id="{CEC4CE65-76BD-D742-9E5B-CCB381168CFA}"/>
                    </a:ext>
                  </a:extLst>
                </p:cNvPr>
                <p:cNvSpPr txBox="1"/>
                <p:nvPr/>
              </p:nvSpPr>
              <p:spPr>
                <a:xfrm>
                  <a:off x="2223519" y="1776447"/>
                  <a:ext cx="786744" cy="3997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MX" sz="800" b="1" kern="120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CDPs 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  <a:p>
                  <a:pPr algn="ctr">
                    <a:spcAft>
                      <a:spcPts val="0"/>
                    </a:spcAft>
                  </a:pPr>
                  <a:r>
                    <a:rPr lang="es-MX" sz="600" b="1" kern="120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(untreated)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8" name="CuadroTexto 14">
                  <a:extLst>
                    <a:ext uri="{FF2B5EF4-FFF2-40B4-BE49-F238E27FC236}">
                      <a16:creationId xmlns:a16="http://schemas.microsoft.com/office/drawing/2014/main" id="{61659EA7-E09D-0841-9105-2128639658C2}"/>
                    </a:ext>
                  </a:extLst>
                </p:cNvPr>
                <p:cNvSpPr txBox="1"/>
                <p:nvPr/>
              </p:nvSpPr>
              <p:spPr>
                <a:xfrm>
                  <a:off x="1867254" y="3096160"/>
                  <a:ext cx="644012" cy="3997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MX" sz="800" b="1" kern="1200">
                      <a:solidFill>
                        <a:srgbClr val="3836FF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CDPs 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  <a:p>
                  <a:pPr algn="ctr">
                    <a:spcAft>
                      <a:spcPts val="0"/>
                    </a:spcAft>
                  </a:pPr>
                  <a:r>
                    <a:rPr lang="es-MX" sz="600" b="1" kern="1200">
                      <a:solidFill>
                        <a:srgbClr val="3836FF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(15 min)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9" name="CuadroTexto 15">
                  <a:extLst>
                    <a:ext uri="{FF2B5EF4-FFF2-40B4-BE49-F238E27FC236}">
                      <a16:creationId xmlns:a16="http://schemas.microsoft.com/office/drawing/2014/main" id="{C83360D6-8C58-5D47-965F-DB47A467B725}"/>
                    </a:ext>
                  </a:extLst>
                </p:cNvPr>
                <p:cNvSpPr txBox="1"/>
                <p:nvPr/>
              </p:nvSpPr>
              <p:spPr>
                <a:xfrm>
                  <a:off x="4614650" y="2271102"/>
                  <a:ext cx="614778" cy="3997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s-MX" sz="800" b="1" kern="1200">
                      <a:solidFill>
                        <a:srgbClr val="3836FF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CDPs 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  <a:p>
                  <a:pPr algn="ctr">
                    <a:spcAft>
                      <a:spcPts val="0"/>
                    </a:spcAft>
                  </a:pPr>
                  <a:r>
                    <a:rPr lang="es-MX" sz="600" b="1" kern="1200">
                      <a:solidFill>
                        <a:srgbClr val="3836FF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(4 h)</a:t>
                  </a:r>
                  <a:endParaRPr lang="es-MX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" name="CuadroTexto 17">
                <a:extLst>
                  <a:ext uri="{FF2B5EF4-FFF2-40B4-BE49-F238E27FC236}">
                    <a16:creationId xmlns:a16="http://schemas.microsoft.com/office/drawing/2014/main" id="{CA937CF7-BCD2-7443-BD1A-E17259351577}"/>
                  </a:ext>
                </a:extLst>
              </p:cNvPr>
              <p:cNvSpPr txBox="1"/>
              <p:nvPr/>
            </p:nvSpPr>
            <p:spPr>
              <a:xfrm>
                <a:off x="1947666" y="1046132"/>
                <a:ext cx="622516" cy="43926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DEGs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FF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(25)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1" name="CuadroTexto 18">
                <a:extLst>
                  <a:ext uri="{FF2B5EF4-FFF2-40B4-BE49-F238E27FC236}">
                    <a16:creationId xmlns:a16="http://schemas.microsoft.com/office/drawing/2014/main" id="{F9614E6F-C5FB-6C45-9710-448C641D7007}"/>
                  </a:ext>
                </a:extLst>
              </p:cNvPr>
              <p:cNvSpPr txBox="1"/>
              <p:nvPr/>
            </p:nvSpPr>
            <p:spPr>
              <a:xfrm>
                <a:off x="2412852" y="3936688"/>
                <a:ext cx="622516" cy="4392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3836FF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DEGs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3836FF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(31)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2" name="CuadroTexto 19">
                <a:extLst>
                  <a:ext uri="{FF2B5EF4-FFF2-40B4-BE49-F238E27FC236}">
                    <a16:creationId xmlns:a16="http://schemas.microsoft.com/office/drawing/2014/main" id="{64046BC2-9806-5A4F-9E27-77F5E27295FD}"/>
                  </a:ext>
                </a:extLst>
              </p:cNvPr>
              <p:cNvSpPr txBox="1"/>
              <p:nvPr/>
            </p:nvSpPr>
            <p:spPr>
              <a:xfrm>
                <a:off x="5020581" y="1909208"/>
                <a:ext cx="622516" cy="4392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00B05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DEGs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algn="ctr">
                  <a:spcAft>
                    <a:spcPts val="0"/>
                  </a:spcAft>
                </a:pPr>
                <a:r>
                  <a:rPr lang="es-MX" sz="800" b="1" kern="1200">
                    <a:solidFill>
                      <a:srgbClr val="00B05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(95)</a:t>
                </a:r>
                <a:endParaRPr lang="es-MX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cxnSp>
          <p:nvCxnSpPr>
            <p:cNvPr id="7" name="Conector recto 6">
              <a:extLst>
                <a:ext uri="{FF2B5EF4-FFF2-40B4-BE49-F238E27FC236}">
                  <a16:creationId xmlns:a16="http://schemas.microsoft.com/office/drawing/2014/main" id="{350C7D32-D137-6B4F-87D9-09A5876036C7}"/>
                </a:ext>
              </a:extLst>
            </p:cNvPr>
            <p:cNvCxnSpPr>
              <a:cxnSpLocks/>
            </p:cNvCxnSpPr>
            <p:nvPr/>
          </p:nvCxnSpPr>
          <p:spPr>
            <a:xfrm>
              <a:off x="608389" y="2965940"/>
              <a:ext cx="5106962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7">
              <a:extLst>
                <a:ext uri="{FF2B5EF4-FFF2-40B4-BE49-F238E27FC236}">
                  <a16:creationId xmlns:a16="http://schemas.microsoft.com/office/drawing/2014/main" id="{8899CDBF-05B6-134C-B59C-05C7EDFF36F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29203" y="356774"/>
              <a:ext cx="0" cy="4127647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CuadroTexto 1">
            <a:extLst>
              <a:ext uri="{FF2B5EF4-FFF2-40B4-BE49-F238E27FC236}">
                <a16:creationId xmlns:a16="http://schemas.microsoft.com/office/drawing/2014/main" id="{3ED10F56-CDDE-5649-8000-DB72C6D344DF}"/>
              </a:ext>
            </a:extLst>
          </p:cNvPr>
          <p:cNvSpPr txBox="1"/>
          <p:nvPr/>
        </p:nvSpPr>
        <p:spPr>
          <a:xfrm>
            <a:off x="663316" y="5565978"/>
            <a:ext cx="5837555" cy="23488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-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analysis of 151 DEGs in HeLa cells treated with CDPs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analysis of mRNA reads data from RNA-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pproach were analyzed by Multivariate Exploratory Techniques, using the Correspondence Analysis (CA) with 2-D PCA correspondence analysis of frequencies w/out grouping variables using the STATISTICA Software System 8.0. Stat Soft. Inc. Response variables (independent) are indicated as: CDPs (untreated) HeLa cells; CDPs (15 min), HeLa cells treated with CDPs (0.1 mg/mL) by 15 min; and CDPs (4 h) treated with CDPs (0.1 mg/mL) by 4 h. Dependent variables are indicated as blue point and gene names in the graph. 2D-PCA of 95 DEGs is shown.</a:t>
            </a:r>
            <a:endParaRPr lang="es-MX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s-MX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3731885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1</TotalTime>
  <Words>165</Words>
  <Application>Microsoft Macintosh PowerPoint</Application>
  <PresentationFormat>Carta (216 x 279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 Campos (UMSNH)</dc:creator>
  <cp:lastModifiedBy>Jesus Campos</cp:lastModifiedBy>
  <cp:revision>82</cp:revision>
  <cp:lastPrinted>2021-01-14T20:58:24Z</cp:lastPrinted>
  <dcterms:created xsi:type="dcterms:W3CDTF">2020-08-31T17:46:22Z</dcterms:created>
  <dcterms:modified xsi:type="dcterms:W3CDTF">2022-02-17T21:19:21Z</dcterms:modified>
</cp:coreProperties>
</file>